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78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o.wang5\Desktop\Luc_p21UTR_Quin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o.wang5\Desktop\miR-22_drug%20resistance%20manuscript\miR-22%20qRT-PCR_breast%20cancer%20lin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Quinn!$K$17</c:f>
              <c:strCache>
                <c:ptCount val="1"/>
                <c:pt idx="0">
                  <c:v>5 nm miR-22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Quinn!$M$18:$M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3356772861059511E-2</c:v>
                  </c:pt>
                  <c:pt idx="2">
                    <c:v>0.11070128757121776</c:v>
                  </c:pt>
                </c:numCache>
              </c:numRef>
            </c:plus>
            <c:minus>
              <c:numRef>
                <c:f>Quinn!$M$18:$M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3356772861059511E-2</c:v>
                  </c:pt>
                  <c:pt idx="2">
                    <c:v>0.110701287571217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Quinn!$J$18:$J$20</c:f>
              <c:strCache>
                <c:ptCount val="3"/>
                <c:pt idx="0">
                  <c:v>Empty vector</c:v>
                </c:pt>
                <c:pt idx="1">
                  <c:v>MT-p21-3'UTR</c:v>
                </c:pt>
                <c:pt idx="2">
                  <c:v>WT-p21-3"UTR</c:v>
                </c:pt>
              </c:strCache>
            </c:strRef>
          </c:cat>
          <c:val>
            <c:numRef>
              <c:f>Quinn!$K$18:$K$20</c:f>
              <c:numCache>
                <c:formatCode>General</c:formatCode>
                <c:ptCount val="3"/>
                <c:pt idx="0">
                  <c:v>1</c:v>
                </c:pt>
                <c:pt idx="1">
                  <c:v>1.0809530569808647</c:v>
                </c:pt>
                <c:pt idx="2">
                  <c:v>1.0519531683875529</c:v>
                </c:pt>
              </c:numCache>
            </c:numRef>
          </c:val>
        </c:ser>
        <c:ser>
          <c:idx val="1"/>
          <c:order val="1"/>
          <c:tx>
            <c:strRef>
              <c:f>Quinn!$L$17</c:f>
              <c:strCache>
                <c:ptCount val="1"/>
                <c:pt idx="0">
                  <c:v>20 nm miR-2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Quinn!$N$18:$N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4296575358315317E-2</c:v>
                  </c:pt>
                  <c:pt idx="2">
                    <c:v>1.8511714893694466E-3</c:v>
                  </c:pt>
                </c:numCache>
              </c:numRef>
            </c:plus>
            <c:minus>
              <c:numRef>
                <c:f>Quinn!$N$18:$N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4296575358315317E-2</c:v>
                  </c:pt>
                  <c:pt idx="2">
                    <c:v>1.851171489369446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Quinn!$J$18:$J$20</c:f>
              <c:strCache>
                <c:ptCount val="3"/>
                <c:pt idx="0">
                  <c:v>Empty vector</c:v>
                </c:pt>
                <c:pt idx="1">
                  <c:v>MT-p21-3'UTR</c:v>
                </c:pt>
                <c:pt idx="2">
                  <c:v>WT-p21-3"UTR</c:v>
                </c:pt>
              </c:strCache>
            </c:strRef>
          </c:cat>
          <c:val>
            <c:numRef>
              <c:f>Quinn!$L$18:$L$20</c:f>
              <c:numCache>
                <c:formatCode>General</c:formatCode>
                <c:ptCount val="3"/>
                <c:pt idx="0">
                  <c:v>1</c:v>
                </c:pt>
                <c:pt idx="1">
                  <c:v>1.0046916276257698</c:v>
                </c:pt>
                <c:pt idx="2">
                  <c:v>0.915624071109253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83246432"/>
        <c:axId val="199635504"/>
      </c:barChart>
      <c:catAx>
        <c:axId val="283246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635504"/>
        <c:crosses val="autoZero"/>
        <c:auto val="1"/>
        <c:lblAlgn val="ctr"/>
        <c:lblOffset val="100"/>
        <c:noMultiLvlLbl val="0"/>
      </c:catAx>
      <c:valAx>
        <c:axId val="199635504"/>
        <c:scaling>
          <c:orientation val="minMax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100" b="1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luciferase activity</a:t>
                </a:r>
                <a:endParaRPr lang="en-US" sz="1100" b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83246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1:$C$2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05579718618295E-3</c:v>
                  </c:pt>
                  <c:pt idx="2">
                    <c:v>2.7760344794023048E-2</c:v>
                  </c:pt>
                  <c:pt idx="3">
                    <c:v>1.7559148451153972E-2</c:v>
                  </c:pt>
                  <c:pt idx="4">
                    <c:v>9.6499462212384594E-3</c:v>
                  </c:pt>
                </c:numCache>
              </c:numRef>
            </c:plus>
            <c:minus>
              <c:numRef>
                <c:f>Sheet1!$C$21:$C$2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05579718618295E-3</c:v>
                  </c:pt>
                  <c:pt idx="2">
                    <c:v>2.7760344794023048E-2</c:v>
                  </c:pt>
                  <c:pt idx="3">
                    <c:v>1.7559148451153972E-2</c:v>
                  </c:pt>
                  <c:pt idx="4">
                    <c:v>9.649946221238459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1:$A$25</c:f>
              <c:strCache>
                <c:ptCount val="5"/>
                <c:pt idx="0">
                  <c:v>HMEC</c:v>
                </c:pt>
                <c:pt idx="1">
                  <c:v>MCF7</c:v>
                </c:pt>
                <c:pt idx="2">
                  <c:v>ZR75-1</c:v>
                </c:pt>
                <c:pt idx="3">
                  <c:v>HCC1419</c:v>
                </c:pt>
                <c:pt idx="4">
                  <c:v>HCC1806</c:v>
                </c:pt>
              </c:strCache>
            </c:strRef>
          </c:cat>
          <c:val>
            <c:numRef>
              <c:f>Sheet1!$B$21:$B$25</c:f>
              <c:numCache>
                <c:formatCode>General</c:formatCode>
                <c:ptCount val="5"/>
                <c:pt idx="0">
                  <c:v>1</c:v>
                </c:pt>
                <c:pt idx="1">
                  <c:v>0.10962514888771761</c:v>
                </c:pt>
                <c:pt idx="2">
                  <c:v>0.28741387352237419</c:v>
                </c:pt>
                <c:pt idx="3">
                  <c:v>0.29560370113471468</c:v>
                </c:pt>
                <c:pt idx="4">
                  <c:v>0.55228307718191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9635112"/>
        <c:axId val="199636680"/>
      </c:barChart>
      <c:catAx>
        <c:axId val="199635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9636680"/>
        <c:crosses val="autoZero"/>
        <c:auto val="1"/>
        <c:lblAlgn val="ctr"/>
        <c:lblOffset val="100"/>
        <c:noMultiLvlLbl val="0"/>
      </c:catAx>
      <c:valAx>
        <c:axId val="1996366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Relative</a:t>
                </a:r>
                <a:r>
                  <a:rPr lang="en-US" sz="1200" b="1" baseline="0">
                    <a:solidFill>
                      <a:sysClr val="windowText" lastClr="000000"/>
                    </a:solidFill>
                    <a:latin typeface="Arial Narrow" panose="020B0606020202030204" pitchFamily="34" charset="0"/>
                  </a:rPr>
                  <a:t> expression of miR-22 (qRT-PCR)</a:t>
                </a:r>
                <a:endParaRPr lang="en-US" sz="1200" b="1">
                  <a:solidFill>
                    <a:sysClr val="windowText" lastClr="000000"/>
                  </a:solidFill>
                  <a:latin typeface="Arial Narrow" panose="020B0606020202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9635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913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69439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338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66380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9588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7674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693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6374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8717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8172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41389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4912D3-483D-4A37-99AE-9AFD7F1ECBD6}" type="datetimeFigureOut">
              <a:rPr lang="en-CA" smtClean="0"/>
              <a:t>09/04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67F1C-2866-461F-ACFD-9C886386FE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78748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chart" Target="../charts/chart2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Content Placeholder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7447351"/>
              </p:ext>
            </p:extLst>
          </p:nvPr>
        </p:nvGraphicFramePr>
        <p:xfrm>
          <a:off x="3485728" y="1869976"/>
          <a:ext cx="4038600" cy="2004060"/>
        </p:xfrm>
        <a:graphic>
          <a:graphicData uri="http://schemas.openxmlformats.org/drawingml/2006/table">
            <a:tbl>
              <a:tblPr/>
              <a:tblGrid>
                <a:gridCol w="1346200"/>
                <a:gridCol w="1346200"/>
                <a:gridCol w="1346200"/>
              </a:tblGrid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microRNA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Expression in 182</a:t>
                      </a:r>
                      <a:r>
                        <a:rPr kumimoji="0" lang="en-US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R</a:t>
                      </a: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-6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Expression in TAM</a:t>
                      </a:r>
                      <a:r>
                        <a:rPr kumimoji="0" lang="en-US" sz="14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R</a:t>
                      </a: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-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miR2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7F3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Up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7F3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Up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7F3F4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miR-2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3F9F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Up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3F9F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Up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3F9FA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miR-23a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7F3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Up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7F3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Up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7F3F4"/>
                    </a:solidFill>
                  </a:tcPr>
                </a:tc>
              </a:tr>
              <a:tr h="3714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miR-27b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3F9F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Dow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3F9F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Dow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3F9FA"/>
                    </a:solidFill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553200" y="630932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Supplementary Fig. S1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6" name="Oval 4"/>
          <p:cNvSpPr>
            <a:spLocks noChangeArrowheads="1"/>
          </p:cNvSpPr>
          <p:nvPr/>
        </p:nvSpPr>
        <p:spPr bwMode="auto">
          <a:xfrm>
            <a:off x="1275928" y="1793776"/>
            <a:ext cx="1081087" cy="1008062"/>
          </a:xfrm>
          <a:prstGeom prst="ellipse">
            <a:avLst/>
          </a:prstGeom>
          <a:noFill/>
          <a:ln w="9525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7" name="Oval 5"/>
          <p:cNvSpPr>
            <a:spLocks noChangeArrowheads="1"/>
          </p:cNvSpPr>
          <p:nvPr/>
        </p:nvSpPr>
        <p:spPr bwMode="auto">
          <a:xfrm>
            <a:off x="1923628" y="1793776"/>
            <a:ext cx="1081087" cy="1008062"/>
          </a:xfrm>
          <a:prstGeom prst="ellipse">
            <a:avLst/>
          </a:prstGeom>
          <a:noFill/>
          <a:ln w="9525">
            <a:solidFill>
              <a:srgbClr val="6600CC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endParaRPr lang="en-US" altLang="en-US"/>
          </a:p>
        </p:txBody>
      </p:sp>
      <p:grpSp>
        <p:nvGrpSpPr>
          <p:cNvPr id="8" name="Group 11"/>
          <p:cNvGrpSpPr>
            <a:grpSpLocks/>
          </p:cNvGrpSpPr>
          <p:nvPr/>
        </p:nvGrpSpPr>
        <p:grpSpPr bwMode="auto">
          <a:xfrm>
            <a:off x="1847428" y="2897088"/>
            <a:ext cx="661987" cy="592137"/>
            <a:chOff x="884" y="3793"/>
            <a:chExt cx="417" cy="373"/>
          </a:xfrm>
        </p:grpSpPr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884" y="4065"/>
              <a:ext cx="46" cy="45"/>
            </a:xfrm>
            <a:prstGeom prst="rect">
              <a:avLst/>
            </a:prstGeom>
            <a:solidFill>
              <a:srgbClr val="6600CC"/>
            </a:solidFill>
            <a:ln w="9525">
              <a:solidFill>
                <a:srgbClr val="6600CC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0" name="Rectangle 8"/>
            <p:cNvSpPr>
              <a:spLocks noChangeArrowheads="1"/>
            </p:cNvSpPr>
            <p:nvPr/>
          </p:nvSpPr>
          <p:spPr bwMode="auto">
            <a:xfrm>
              <a:off x="884" y="3884"/>
              <a:ext cx="46" cy="45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endParaRPr lang="en-US" altLang="en-US"/>
            </a:p>
          </p:txBody>
        </p:sp>
        <p:sp>
          <p:nvSpPr>
            <p:cNvPr id="11" name="Text Box 9"/>
            <p:cNvSpPr txBox="1">
              <a:spLocks noChangeArrowheads="1"/>
            </p:cNvSpPr>
            <p:nvPr/>
          </p:nvSpPr>
          <p:spPr bwMode="auto">
            <a:xfrm>
              <a:off x="943" y="3793"/>
              <a:ext cx="259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/>
                <a:t>ICI</a:t>
              </a:r>
            </a:p>
          </p:txBody>
        </p:sp>
        <p:sp>
          <p:nvSpPr>
            <p:cNvPr id="12" name="Text Box 10"/>
            <p:cNvSpPr txBox="1">
              <a:spLocks noChangeArrowheads="1"/>
            </p:cNvSpPr>
            <p:nvPr/>
          </p:nvSpPr>
          <p:spPr bwMode="auto">
            <a:xfrm>
              <a:off x="943" y="3974"/>
              <a:ext cx="358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400" b="1"/>
                <a:t>TAM</a:t>
              </a:r>
            </a:p>
          </p:txBody>
        </p:sp>
      </p:grpSp>
      <p:sp>
        <p:nvSpPr>
          <p:cNvPr id="13" name="Text Box 12"/>
          <p:cNvSpPr txBox="1">
            <a:spLocks noChangeArrowheads="1"/>
          </p:cNvSpPr>
          <p:nvPr/>
        </p:nvSpPr>
        <p:spPr bwMode="auto">
          <a:xfrm>
            <a:off x="1496590" y="2135088"/>
            <a:ext cx="2841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b="1"/>
              <a:t>9</a:t>
            </a:r>
          </a:p>
        </p:txBody>
      </p:sp>
      <p:sp>
        <p:nvSpPr>
          <p:cNvPr id="14" name="Text Box 13"/>
          <p:cNvSpPr txBox="1">
            <a:spLocks noChangeArrowheads="1"/>
          </p:cNvSpPr>
          <p:nvPr/>
        </p:nvSpPr>
        <p:spPr bwMode="auto">
          <a:xfrm>
            <a:off x="2001415" y="2136676"/>
            <a:ext cx="2841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b="1"/>
              <a:t>4</a:t>
            </a:r>
          </a:p>
        </p:txBody>
      </p:sp>
      <p:sp>
        <p:nvSpPr>
          <p:cNvPr id="15" name="Text Box 14"/>
          <p:cNvSpPr txBox="1">
            <a:spLocks noChangeArrowheads="1"/>
          </p:cNvSpPr>
          <p:nvPr/>
        </p:nvSpPr>
        <p:spPr bwMode="auto">
          <a:xfrm>
            <a:off x="2504653" y="2136676"/>
            <a:ext cx="2841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1400" b="1"/>
              <a:t>9</a:t>
            </a:r>
          </a:p>
        </p:txBody>
      </p:sp>
      <p:sp>
        <p:nvSpPr>
          <p:cNvPr id="17" name="TextBox 12"/>
          <p:cNvSpPr txBox="1">
            <a:spLocks noChangeArrowheads="1"/>
          </p:cNvSpPr>
          <p:nvPr/>
        </p:nvSpPr>
        <p:spPr bwMode="auto">
          <a:xfrm>
            <a:off x="1710902" y="3473350"/>
            <a:ext cx="8969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en-US" dirty="0"/>
              <a:t>p &lt; 0.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409528" y="1412776"/>
            <a:ext cx="4038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altLang="zh-CN" sz="1200" b="1" dirty="0"/>
              <a:t>Differential expression of miRNAs with identical alteration in both 182</a:t>
            </a:r>
            <a:r>
              <a:rPr lang="en-US" altLang="zh-CN" sz="1200" b="1" baseline="30000" dirty="0"/>
              <a:t>R</a:t>
            </a:r>
            <a:r>
              <a:rPr lang="en-US" altLang="zh-CN" sz="1200" b="1" dirty="0"/>
              <a:t>-6 and TAM</a:t>
            </a:r>
            <a:r>
              <a:rPr lang="en-US" altLang="zh-CN" sz="1200" b="1" baseline="30000" dirty="0"/>
              <a:t>R</a:t>
            </a:r>
            <a:r>
              <a:rPr lang="en-US" altLang="zh-CN" sz="1200" b="1" dirty="0"/>
              <a:t>-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66228" y="156517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1210628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6"/>
          <p:cNvSpPr txBox="1">
            <a:spLocks noChangeArrowheads="1"/>
          </p:cNvSpPr>
          <p:nvPr/>
        </p:nvSpPr>
        <p:spPr bwMode="auto">
          <a:xfrm>
            <a:off x="1665784" y="2024728"/>
            <a:ext cx="49244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en-US" sz="1200" b="1" dirty="0"/>
              <a:t>ER</a:t>
            </a:r>
            <a:r>
              <a:rPr lang="el-GR" altLang="en-US" sz="1200" b="1" dirty="0"/>
              <a:t>α</a:t>
            </a:r>
            <a:endParaRPr lang="en-US" altLang="en-US" sz="1200" b="1" dirty="0"/>
          </a:p>
        </p:txBody>
      </p:sp>
      <p:sp>
        <p:nvSpPr>
          <p:cNvPr id="3" name="TextBox 8"/>
          <p:cNvSpPr txBox="1">
            <a:spLocks noChangeArrowheads="1"/>
          </p:cNvSpPr>
          <p:nvPr/>
        </p:nvSpPr>
        <p:spPr bwMode="auto">
          <a:xfrm rot="16200000">
            <a:off x="918314" y="1178701"/>
            <a:ext cx="649537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lnSpc>
                <a:spcPct val="200000"/>
              </a:lnSpc>
            </a:pPr>
            <a:r>
              <a:rPr lang="en-US" altLang="en-US" sz="1200" dirty="0"/>
              <a:t>S05</a:t>
            </a:r>
          </a:p>
          <a:p>
            <a:pPr eaLnBrk="1" hangingPunct="1">
              <a:lnSpc>
                <a:spcPct val="200000"/>
              </a:lnSpc>
            </a:pPr>
            <a:r>
              <a:rPr lang="en-US" altLang="en-US" sz="1200" dirty="0" smtClean="0"/>
              <a:t>182</a:t>
            </a:r>
            <a:r>
              <a:rPr lang="en-US" altLang="en-US" sz="1200" baseline="30000" dirty="0" smtClean="0"/>
              <a:t>R</a:t>
            </a:r>
            <a:r>
              <a:rPr lang="en-US" altLang="en-US" sz="1200" dirty="0" smtClean="0"/>
              <a:t>-6</a:t>
            </a:r>
            <a:endParaRPr lang="en-US" altLang="en-US" sz="1200" dirty="0"/>
          </a:p>
        </p:txBody>
      </p:sp>
      <p:sp>
        <p:nvSpPr>
          <p:cNvPr id="4" name="TextBox 7"/>
          <p:cNvSpPr txBox="1">
            <a:spLocks noChangeArrowheads="1"/>
          </p:cNvSpPr>
          <p:nvPr/>
        </p:nvSpPr>
        <p:spPr bwMode="auto">
          <a:xfrm>
            <a:off x="1672449" y="2515123"/>
            <a:ext cx="4491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en-US" sz="1200" b="1" dirty="0"/>
              <a:t>p21</a:t>
            </a:r>
          </a:p>
        </p:txBody>
      </p:sp>
      <p:sp>
        <p:nvSpPr>
          <p:cNvPr id="7" name="TextBox 4"/>
          <p:cNvSpPr txBox="1">
            <a:spLocks noChangeArrowheads="1"/>
          </p:cNvSpPr>
          <p:nvPr/>
        </p:nvSpPr>
        <p:spPr bwMode="auto">
          <a:xfrm>
            <a:off x="1669803" y="4041798"/>
            <a:ext cx="5693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en-US" sz="1200" b="1" dirty="0" smtClean="0"/>
              <a:t>Actin</a:t>
            </a:r>
            <a:endParaRPr lang="en-US" altLang="en-US" sz="12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r="35893"/>
          <a:stretch/>
        </p:blipFill>
        <p:spPr>
          <a:xfrm>
            <a:off x="902516" y="1924699"/>
            <a:ext cx="763268" cy="4572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r="34000"/>
          <a:stretch/>
        </p:blipFill>
        <p:spPr>
          <a:xfrm>
            <a:off x="897688" y="2459071"/>
            <a:ext cx="768096" cy="44689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/>
          <a:srcRect r="36973"/>
          <a:stretch/>
        </p:blipFill>
        <p:spPr>
          <a:xfrm>
            <a:off x="897688" y="4005064"/>
            <a:ext cx="768096" cy="40947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867400" y="617220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dirty="0" smtClean="0">
                <a:solidFill>
                  <a:srgbClr val="FF0000"/>
                </a:solidFill>
              </a:rPr>
              <a:t>Fig. S2</a:t>
            </a:r>
            <a:endParaRPr lang="en-US" dirty="0">
              <a:solidFill>
                <a:srgbClr val="FF0000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/>
          <a:srcRect l="2303" t="25931" r="12416" b="29676"/>
          <a:stretch/>
        </p:blipFill>
        <p:spPr>
          <a:xfrm>
            <a:off x="3563888" y="1666938"/>
            <a:ext cx="1738312" cy="452438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302198" y="1702650"/>
            <a:ext cx="1047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yclin D1</a:t>
            </a:r>
            <a:endParaRPr lang="en-US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3649613" y="1571687"/>
            <a:ext cx="66198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530675" y="1571687"/>
            <a:ext cx="66198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721052" y="1304982"/>
            <a:ext cx="15648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05              18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/>
          <a:srcRect l="5208" t="28713" r="18333" b="22277"/>
          <a:stretch/>
        </p:blipFill>
        <p:spPr>
          <a:xfrm>
            <a:off x="3563888" y="2669480"/>
            <a:ext cx="1747838" cy="47148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302191" y="267662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in</a:t>
            </a:r>
            <a:endParaRPr lang="en-US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426" t="33868" r="31198" b="47224"/>
          <a:stretch/>
        </p:blipFill>
        <p:spPr>
          <a:xfrm>
            <a:off x="3582938" y="2169078"/>
            <a:ext cx="1728788" cy="433387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5306946" y="2171466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27</a:t>
            </a:r>
            <a:endParaRPr lang="en-US" dirty="0"/>
          </a:p>
        </p:txBody>
      </p:sp>
      <p:sp>
        <p:nvSpPr>
          <p:cNvPr id="23" name="TextBox 4"/>
          <p:cNvSpPr txBox="1">
            <a:spLocks noChangeArrowheads="1"/>
          </p:cNvSpPr>
          <p:nvPr/>
        </p:nvSpPr>
        <p:spPr bwMode="auto">
          <a:xfrm>
            <a:off x="1666297" y="3132297"/>
            <a:ext cx="6014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en-US" sz="1200" b="1" dirty="0" smtClean="0"/>
              <a:t>CDK2</a:t>
            </a:r>
            <a:endParaRPr lang="en-US" altLang="en-US" sz="1200" b="1" dirty="0"/>
          </a:p>
        </p:txBody>
      </p:sp>
      <p:sp>
        <p:nvSpPr>
          <p:cNvPr id="24" name="TextBox 4"/>
          <p:cNvSpPr txBox="1">
            <a:spLocks noChangeArrowheads="1"/>
          </p:cNvSpPr>
          <p:nvPr/>
        </p:nvSpPr>
        <p:spPr bwMode="auto">
          <a:xfrm>
            <a:off x="1691680" y="3583796"/>
            <a:ext cx="6014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en-US" sz="1200" b="1" dirty="0" smtClean="0"/>
              <a:t>CDK6</a:t>
            </a:r>
            <a:endParaRPr lang="en-US" altLang="en-US" sz="12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551976" y="119675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31746" y="123297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9"/>
          <a:srcRect l="13486" t="10077" r="12351" b="39470"/>
          <a:stretch/>
        </p:blipFill>
        <p:spPr>
          <a:xfrm>
            <a:off x="899592" y="2996952"/>
            <a:ext cx="768096" cy="447887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0"/>
          <a:srcRect l="11906" t="16747" r="7664" b="18604"/>
          <a:stretch/>
        </p:blipFill>
        <p:spPr>
          <a:xfrm>
            <a:off x="904353" y="3501008"/>
            <a:ext cx="768096" cy="428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8546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2856433"/>
              </p:ext>
            </p:extLst>
          </p:nvPr>
        </p:nvGraphicFramePr>
        <p:xfrm>
          <a:off x="1371600" y="241776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1505285" y="993304"/>
            <a:ext cx="3904915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21 3’UTR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5' C       ACC             C 3‘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UAGUUCU   UCA   GGCAGCU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GUCAAGA   AGU   CCGUCGA  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iR-2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3' U             UGA       A 5'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400800" y="647700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3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143000" y="76470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43000" y="217875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716620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52600" y="149433"/>
            <a:ext cx="42565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 Narrow" panose="020B0606020202030204" pitchFamily="34" charset="0"/>
              </a:rPr>
              <a:t>The highly conserved miR-22 targeting site in FOXP1 mRNA 3’UTR</a:t>
            </a:r>
            <a:endParaRPr lang="en-US" sz="1200" b="1" dirty="0">
              <a:latin typeface="Arial Narrow" panose="020B060602020203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631513" y="3581400"/>
            <a:ext cx="427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 Narrow" panose="020B0606020202030204" pitchFamily="34" charset="0"/>
              </a:rPr>
              <a:t>The highly conserved miR-22 targeting site in HDAC4 mRNA 3’UTR</a:t>
            </a:r>
            <a:endParaRPr lang="en-US" sz="1200" b="1" dirty="0">
              <a:latin typeface="Arial Narrow" panose="020B060602020203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371600" y="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7" t="1876" r="25655" b="1670"/>
          <a:stretch/>
        </p:blipFill>
        <p:spPr>
          <a:xfrm>
            <a:off x="1715038" y="431077"/>
            <a:ext cx="4114800" cy="299792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0" t="2815" r="21150" b="3607"/>
          <a:stretch/>
        </p:blipFill>
        <p:spPr>
          <a:xfrm>
            <a:off x="1726502" y="3860077"/>
            <a:ext cx="4114800" cy="299792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172200" y="6248400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 S4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371600" y="34714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71559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9600" t="18605" r="10400" b="25581"/>
          <a:stretch/>
        </p:blipFill>
        <p:spPr>
          <a:xfrm>
            <a:off x="3505200" y="3687472"/>
            <a:ext cx="1463040" cy="35112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53000" y="3715273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ET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8"/>
          <p:cNvSpPr txBox="1">
            <a:spLocks noChangeArrowheads="1"/>
          </p:cNvSpPr>
          <p:nvPr/>
        </p:nvSpPr>
        <p:spPr bwMode="auto">
          <a:xfrm rot="16200000">
            <a:off x="3568261" y="2293861"/>
            <a:ext cx="1257075" cy="15124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R-22 mimic</a:t>
            </a:r>
          </a:p>
          <a:p>
            <a:pPr>
              <a:lnSpc>
                <a:spcPct val="200000"/>
              </a:lnSpc>
            </a:pP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 A</a:t>
            </a:r>
          </a:p>
          <a:p>
            <a:pPr>
              <a:lnSpc>
                <a:spcPct val="200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R-22 inhibitor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324600" y="617220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5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953000" y="4218801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l="7469" t="29358" r="10191" b="19266"/>
          <a:stretch/>
        </p:blipFill>
        <p:spPr>
          <a:xfrm>
            <a:off x="3505200" y="4137838"/>
            <a:ext cx="1463040" cy="4564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191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5867400" y="6248400"/>
            <a:ext cx="22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6</a:t>
            </a:r>
            <a:endParaRPr lang="en-US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2"/>
          <a:srcRect l="5974" t="22212" r="5661" b="23243"/>
          <a:stretch/>
        </p:blipFill>
        <p:spPr>
          <a:xfrm>
            <a:off x="1295405" y="3166646"/>
            <a:ext cx="1645920" cy="44260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0" name="TextBox 19"/>
          <p:cNvSpPr txBox="1"/>
          <p:nvPr/>
        </p:nvSpPr>
        <p:spPr>
          <a:xfrm>
            <a:off x="2903638" y="322824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918295" y="3836122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/>
          <a:srcRect l="4745" t="19586" r="5592" b="24858"/>
          <a:stretch/>
        </p:blipFill>
        <p:spPr>
          <a:xfrm>
            <a:off x="1302052" y="3692514"/>
            <a:ext cx="1645920" cy="46473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/>
          <a:srcRect l="12356" t="45370" r="7278" b="22208"/>
          <a:stretch/>
        </p:blipFill>
        <p:spPr>
          <a:xfrm>
            <a:off x="1295400" y="2709446"/>
            <a:ext cx="1645920" cy="38810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4" name="TextBox 23"/>
          <p:cNvSpPr txBox="1"/>
          <p:nvPr/>
        </p:nvSpPr>
        <p:spPr>
          <a:xfrm>
            <a:off x="2910165" y="2733638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65 (Ser536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9106290"/>
              </p:ext>
            </p:extLst>
          </p:nvPr>
        </p:nvGraphicFramePr>
        <p:xfrm>
          <a:off x="4514850" y="1109246"/>
          <a:ext cx="36385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5948369" y="269118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477682" y="235262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549237" y="1948232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011074" y="2352634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6"/>
          <a:srcRect l="8706" t="23366" b="19107"/>
          <a:stretch/>
        </p:blipFill>
        <p:spPr>
          <a:xfrm>
            <a:off x="1295400" y="1644551"/>
            <a:ext cx="1645920" cy="47987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7"/>
          <a:srcRect t="17242" r="1621" b="24138"/>
          <a:stretch/>
        </p:blipFill>
        <p:spPr>
          <a:xfrm>
            <a:off x="1295400" y="2176046"/>
            <a:ext cx="1645920" cy="46121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4" name="TextBox 33"/>
          <p:cNvSpPr txBox="1"/>
          <p:nvPr/>
        </p:nvSpPr>
        <p:spPr>
          <a:xfrm>
            <a:off x="2913624" y="1708642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HER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911768" y="2280047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R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1698459" y="401388"/>
            <a:ext cx="856325" cy="166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75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MEC</a:t>
            </a:r>
          </a:p>
          <a:p>
            <a:pPr>
              <a:lnSpc>
                <a:spcPct val="175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  <a:p>
            <a:pPr>
              <a:lnSpc>
                <a:spcPct val="175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ZR75-1</a:t>
            </a:r>
          </a:p>
          <a:p>
            <a:pPr>
              <a:lnSpc>
                <a:spcPct val="175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CC1419</a:t>
            </a:r>
          </a:p>
          <a:p>
            <a:pPr>
              <a:lnSpc>
                <a:spcPct val="175000"/>
              </a:lnSpc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CC180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87058" y="6858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316058" y="9906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767083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171</Words>
  <Application>Microsoft Office PowerPoint</Application>
  <PresentationFormat>On-screen Show (4:3)</PresentationFormat>
  <Paragraphs>7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宋体</vt:lpstr>
      <vt:lpstr>Arial</vt:lpstr>
      <vt:lpstr>Arial Narrow</vt:lpstr>
      <vt:lpstr>Calibri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ga Kovalchuk</dc:creator>
  <cp:lastModifiedBy>Wang, Bo</cp:lastModifiedBy>
  <cp:revision>8</cp:revision>
  <dcterms:created xsi:type="dcterms:W3CDTF">2018-02-08T18:12:32Z</dcterms:created>
  <dcterms:modified xsi:type="dcterms:W3CDTF">2018-04-09T20:09:15Z</dcterms:modified>
</cp:coreProperties>
</file>